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57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6" autoAdjust="0"/>
    <p:restoredTop sz="94660"/>
  </p:normalViewPr>
  <p:slideViewPr>
    <p:cSldViewPr snapToGrid="0">
      <p:cViewPr varScale="1">
        <p:scale>
          <a:sx n="66" d="100"/>
          <a:sy n="66" d="100"/>
        </p:scale>
        <p:origin x="90" y="7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117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989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202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612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091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776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749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877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177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701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864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7E0B8-6BB5-4A15-8EB5-50D9370A449E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39D86-EDCD-45E9-BF9E-35C73A6B8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16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5037" y="954232"/>
            <a:ext cx="8467725" cy="49911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7035" y="145473"/>
            <a:ext cx="806342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Coomassie stain of myofibril proteins (raw image)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 flipH="1">
            <a:off x="1537855" y="2348345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79135" y="2137535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yosin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Connector 8"/>
          <p:cNvCxnSpPr/>
          <p:nvPr/>
        </p:nvCxnSpPr>
        <p:spPr>
          <a:xfrm flipH="1">
            <a:off x="1537855" y="3981087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56935" y="3770277"/>
            <a:ext cx="7553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1175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7035" y="145473"/>
            <a:ext cx="693427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blot image of ACTN2 (raw image)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 flipH="1">
            <a:off x="2132941" y="3088574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30791" y="2877764"/>
            <a:ext cx="199285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redicted target</a:t>
            </a:r>
          </a:p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~100 </a:t>
            </a:r>
            <a:r>
              <a:rPr lang="en-US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9875" y="1343025"/>
            <a:ext cx="6572250" cy="2343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50590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7035" y="145473"/>
            <a:ext cx="68065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blot image of MYOT (raw image)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 flipH="1">
            <a:off x="2132941" y="3088574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30791" y="2877764"/>
            <a:ext cx="199285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redicted target</a:t>
            </a:r>
          </a:p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~63 </a:t>
            </a:r>
            <a:r>
              <a:rPr lang="en-US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 flipH="1">
            <a:off x="9280300" y="3734813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9802156" y="3538516"/>
            <a:ext cx="223811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on-specific band</a:t>
            </a:r>
          </a:p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~30 </a:t>
            </a:r>
            <a:r>
              <a:rPr lang="en-US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6256" y="2670629"/>
            <a:ext cx="6629400" cy="259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0882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7035" y="145473"/>
            <a:ext cx="72314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blot image of SORBS2 (raw image)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5587" y="2528887"/>
            <a:ext cx="6600825" cy="1800225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 flipH="1">
            <a:off x="2132941" y="3088574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30791" y="2877764"/>
            <a:ext cx="199285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redicted target</a:t>
            </a:r>
          </a:p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~100 </a:t>
            </a:r>
            <a:r>
              <a:rPr lang="en-US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 flipH="1">
            <a:off x="9396412" y="3342927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9918268" y="3146630"/>
            <a:ext cx="223811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on-specific band</a:t>
            </a:r>
          </a:p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~70 </a:t>
            </a:r>
            <a:r>
              <a:rPr lang="en-US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78675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7035" y="145473"/>
            <a:ext cx="70133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blot image of MYOZ1 (raw image)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 flipH="1">
            <a:off x="2089399" y="3306287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30791" y="2921307"/>
            <a:ext cx="199285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redicted target</a:t>
            </a:r>
          </a:p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~35 </a:t>
            </a:r>
            <a:r>
              <a:rPr lang="en-US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3187" y="1624012"/>
            <a:ext cx="6905625" cy="3609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97657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7035" y="145473"/>
            <a:ext cx="75487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blot image of OXPHOS (raw image)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 flipH="1">
            <a:off x="2190997" y="3306287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751179" y="3091718"/>
            <a:ext cx="14398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omplex V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0354" y="2360385"/>
            <a:ext cx="8343900" cy="3124200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 flipH="1">
            <a:off x="2183742" y="3545773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743924" y="3331204"/>
            <a:ext cx="14798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omplex III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 flipH="1">
            <a:off x="2183742" y="3740750"/>
            <a:ext cx="540327" cy="1817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736668" y="3686804"/>
            <a:ext cx="15103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omplex IV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 flipH="1">
            <a:off x="2183742" y="4184302"/>
            <a:ext cx="540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43924" y="3969733"/>
            <a:ext cx="14093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omplex II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 flipH="1">
            <a:off x="2153284" y="4382985"/>
            <a:ext cx="540327" cy="1817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51180" y="4325333"/>
            <a:ext cx="13388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omplex I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/>
          <p:cNvCxnSpPr/>
          <p:nvPr/>
        </p:nvCxnSpPr>
        <p:spPr>
          <a:xfrm flipH="1">
            <a:off x="2247018" y="4696693"/>
            <a:ext cx="540327" cy="1817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77168" y="4835973"/>
            <a:ext cx="22381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on-specific band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6811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04</Words>
  <Application>Microsoft Office PowerPoint</Application>
  <PresentationFormat>Widescreen</PresentationFormat>
  <Paragraphs>2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uburn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Roberts</dc:creator>
  <cp:lastModifiedBy>Michael Roberts</cp:lastModifiedBy>
  <cp:revision>2</cp:revision>
  <dcterms:created xsi:type="dcterms:W3CDTF">2018-05-11T22:16:41Z</dcterms:created>
  <dcterms:modified xsi:type="dcterms:W3CDTF">2018-05-11T22:20:52Z</dcterms:modified>
</cp:coreProperties>
</file>